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6076" autoAdjust="0"/>
  </p:normalViewPr>
  <p:slideViewPr>
    <p:cSldViewPr snapToGrid="0">
      <p:cViewPr varScale="1">
        <p:scale>
          <a:sx n="62" d="100"/>
          <a:sy n="62" d="100"/>
        </p:scale>
        <p:origin x="26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AF377EE7-6581-7F50-F08F-782510F853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199" y="2430291"/>
            <a:ext cx="5338191" cy="4657833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77213806-5BAD-4D56-AE65-19EF6A2D749F}"/>
              </a:ext>
            </a:extLst>
          </p:cNvPr>
          <p:cNvSpPr/>
          <p:nvPr/>
        </p:nvSpPr>
        <p:spPr>
          <a:xfrm>
            <a:off x="356996" y="7273953"/>
            <a:ext cx="6300596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4: Figure S4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impact of the seed exudate from different genotypes on growth of 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GB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ssicicola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t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FU/mL, assessed after 10 d of imbibition before collecting the exudate. Data are expressed as the normalized growth ratio between the AUC with and without exudate. Points in the box plots correspond to three replicates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dashed line corresponds to control growth without exudate. The star indicates a significant difference from control (t-test or Mann-Whitney test, p&lt;0.05). Different letters indicate a significant difference between genotypes (Kruskal-Wallis test, Dunn method, p&lt;0.05). G (%), germination percentage determined on 60 seeds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1534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6</TotalTime>
  <Words>121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10</cp:revision>
  <dcterms:created xsi:type="dcterms:W3CDTF">2023-08-10T14:53:51Z</dcterms:created>
  <dcterms:modified xsi:type="dcterms:W3CDTF">2024-01-17T14:34:05Z</dcterms:modified>
</cp:coreProperties>
</file>